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9" roundtripDataSignature="AMtx7miSg/JPY6tMhu54XAUhjBwWZFXsD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76818"/>
  </p:normalViewPr>
  <p:slideViewPr>
    <p:cSldViewPr snapToGrid="0" snapToObjects="1">
      <p:cViewPr varScale="1">
        <p:scale>
          <a:sx n="86" d="100"/>
          <a:sy n="86" d="100"/>
        </p:scale>
        <p:origin x="15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2. Soft tissues with pathological calcification up-regulate pathways involved in adaptive immune response, and down-regulate pathways of intracellular transport. (A) Overlap between up-regulated, and (B) down-regulated genes (FDR&lt;0.05) in calcified aorta, artery tibial, and coronary artery. No statistically significant (FDR&lt;0.05) gene changes were found in calcified pituitary. (C) GO and (D) </a:t>
            </a:r>
            <a:r>
              <a:rPr lang="en-US" sz="1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sigDB</a:t>
            </a: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GSEA for differentially expressed genes in calcified aorta, artery tibial, coronary artery and pituitary, as well as all tissues combined together (</a:t>
            </a:r>
            <a:r>
              <a:rPr lang="en-US" sz="1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ll_Tissues</a:t>
            </a: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 adjusted for sex, age, and </a:t>
            </a:r>
            <a:r>
              <a:rPr lang="en-US" sz="1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ardyScale</a:t>
            </a: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f </a:t>
            </a:r>
            <a:r>
              <a:rPr lang="en-US" sz="1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TEx</a:t>
            </a: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ubjects. (E) GSEA for custom-created gene markers of human immune cell populations. Size of the dot is -log10 of FDR-adjusted p-values, and color is normalized enrichment score. 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</a:pP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 dirty="0"/>
          </a:p>
        </p:txBody>
      </p:sp>
      <p:sp>
        <p:nvSpPr>
          <p:cNvPr id="105" name="Google Shape;105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Google Shape;119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.3 Gene expression correlation between manually assigned calcification grade in human soft tissues for subjects from </a:t>
            </a:r>
            <a:r>
              <a:rPr lang="en-US" sz="1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TEx</a:t>
            </a: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database and (A) expression levels of genes known to be involved in pathological and natural calcification, and (B) expression levels of gene associated with immune-associated inflammation. Pearson correlation coefficients are shown. </a:t>
            </a:r>
            <a:endParaRPr sz="1400" dirty="0">
              <a:solidFill>
                <a:schemeClr val="dk1"/>
              </a:solidFill>
            </a:endParaRP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 dirty="0"/>
          </a:p>
        </p:txBody>
      </p:sp>
      <p:sp>
        <p:nvSpPr>
          <p:cNvPr id="120" name="Google Shape;120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Google Shape;128;p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</a:pPr>
            <a:r>
              <a:rPr lang="en-US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4. Pathologies co-occurring with pathological calcification. (A ) Number of most common pathologies detected by H&amp;E staining of corresponding human tissues. (B) Calcification grade in aorta, coronary artery and artery tibial that also presents (B) sclerotic changes, (C) </a:t>
            </a:r>
            <a:r>
              <a:rPr lang="en-US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therosis</a:t>
            </a:r>
            <a:r>
              <a:rPr lang="en-US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r (D) atherosclerosis. TRUE - indicate presence of corresponding pathogenic change and, FALSE - indicates the absence of it. P-value was calculated using Mann-Whitney test.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 dirty="0"/>
          </a:p>
        </p:txBody>
      </p:sp>
      <p:sp>
        <p:nvSpPr>
          <p:cNvPr id="129" name="Google Shape;129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Заголовок и объект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1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10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Заголовок и вертикальный текст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9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Вертикальный заголовок и текст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0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0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2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2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Титульный слайд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1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1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Заголовок раздела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12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2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Два объекта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13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Сравнение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4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4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14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4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14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Только заголовок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Пустой слайд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Объект с подписью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7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7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7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Рисунок с подписью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8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8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8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94400" y="2700150"/>
            <a:ext cx="3093399" cy="2577825"/>
          </a:xfrm>
          <a:prstGeom prst="rect">
            <a:avLst/>
          </a:prstGeom>
          <a:noFill/>
          <a:ln>
            <a:noFill/>
          </a:ln>
        </p:spPr>
      </p:pic>
      <p:sp>
        <p:nvSpPr>
          <p:cNvPr id="85" name="Google Shape;85;p1"/>
          <p:cNvSpPr/>
          <p:nvPr/>
        </p:nvSpPr>
        <p:spPr>
          <a:xfrm>
            <a:off x="69325" y="5277975"/>
            <a:ext cx="12192000" cy="1420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</a:pP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.1.  Calcification of soft tissues is a common age-related pathology. (A) 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verlap 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f GTEx subjects 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o developed 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calcification in aorta, 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rtery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ibial, pituitar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y, or 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ronary artery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s detected by H&amp;E staining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(B) 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presentative e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xamples of unaffected (grade 0), mildly calcified (grade 1-2) an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0"/>
                  </a:ext>
                </a:extLst>
              </a:rPr>
              <a:t>d severely calcified (grade 4) coronary arteries stained 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1"/>
                  </a:ext>
                </a:extLst>
              </a:rPr>
              <a:t>with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2"/>
                  </a:ext>
                </a:extLst>
              </a:rPr>
              <a:t> H&amp;E. 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3"/>
                  </a:ext>
                </a:extLst>
              </a:rPr>
              <a:t>Images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4"/>
                  </a:ext>
                </a:extLst>
              </a:rPr>
              <a:t> were downloaded from GTEx Histology viewer. (C) Proportion of 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5"/>
                  </a:ext>
                </a:extLst>
              </a:rPr>
              <a:t>subjects with pathologically calcified tissues by age groups. Shadowed areas are 95% confidence intervals. 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D) 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alcification grade of men and women from GTEx database.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-value was calculated with wilcoxon test.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6"/>
                  </a:ext>
                </a:extLst>
              </a:rPr>
              <a:t> (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7"/>
                  </a:ext>
                </a:extLst>
              </a:rPr>
              <a:t>E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8"/>
                  </a:ext>
                </a:extLst>
              </a:rPr>
              <a:t>)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lcification grade in aorta, 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rtery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ibial, coronary artery a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d pituitary by age group among GTEx subjects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(F) T</a:t>
            </a:r>
            <a:r>
              <a:rPr lang="en-US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tal number of cases of pathological calcification by tissue. </a:t>
            </a:r>
            <a:r>
              <a:rPr lang="en-US"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RUE indicates presence of calcification, FALSE indicates absence of calcification.</a:t>
            </a:r>
            <a:endParaRPr sz="15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6" name="Google Shape;86;p1"/>
          <p:cNvSpPr txBox="1"/>
          <p:nvPr/>
        </p:nvSpPr>
        <p:spPr>
          <a:xfrm>
            <a:off x="449600" y="357875"/>
            <a:ext cx="489900" cy="39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7" name="Google Shape;87;p1"/>
          <p:cNvSpPr txBox="1"/>
          <p:nvPr/>
        </p:nvSpPr>
        <p:spPr>
          <a:xfrm>
            <a:off x="3487800" y="330425"/>
            <a:ext cx="389100" cy="450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8" name="Google Shape;88;p1"/>
          <p:cNvSpPr txBox="1"/>
          <p:nvPr/>
        </p:nvSpPr>
        <p:spPr>
          <a:xfrm>
            <a:off x="449600" y="2519950"/>
            <a:ext cx="389100" cy="450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4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9" name="Google Shape;89;p1"/>
          <p:cNvSpPr txBox="1"/>
          <p:nvPr/>
        </p:nvSpPr>
        <p:spPr>
          <a:xfrm>
            <a:off x="6252300" y="2521763"/>
            <a:ext cx="389100" cy="450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b="1">
                <a:latin typeface="Calibri"/>
                <a:ea typeface="Calibri"/>
                <a:cs typeface="Calibri"/>
                <a:sym typeface="Calibri"/>
              </a:rPr>
              <a:t>E</a:t>
            </a:r>
            <a:endParaRPr sz="14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0" name="Google Shape;90;p1"/>
          <p:cNvSpPr txBox="1"/>
          <p:nvPr/>
        </p:nvSpPr>
        <p:spPr>
          <a:xfrm>
            <a:off x="8468313" y="2521763"/>
            <a:ext cx="389100" cy="450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b="1">
                <a:latin typeface="Calibri"/>
                <a:ea typeface="Calibri"/>
                <a:cs typeface="Calibri"/>
                <a:sym typeface="Calibri"/>
              </a:rPr>
              <a:t>F</a:t>
            </a:r>
            <a:endParaRPr sz="14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1" name="Google Shape;91;p1"/>
          <p:cNvSpPr txBox="1"/>
          <p:nvPr/>
        </p:nvSpPr>
        <p:spPr>
          <a:xfrm>
            <a:off x="3847263" y="2547750"/>
            <a:ext cx="389100" cy="450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b="1">
                <a:latin typeface="Calibri"/>
                <a:ea typeface="Calibri"/>
                <a:cs typeface="Calibri"/>
                <a:sym typeface="Calibri"/>
              </a:rPr>
              <a:t>D</a:t>
            </a:r>
            <a:endParaRPr sz="14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2" name="Google Shape;92;p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9638800" y="204125"/>
            <a:ext cx="2092425" cy="1909818"/>
          </a:xfrm>
          <a:prstGeom prst="rect">
            <a:avLst/>
          </a:prstGeom>
          <a:noFill/>
          <a:ln>
            <a:noFill/>
          </a:ln>
        </p:spPr>
      </p:pic>
      <p:pic>
        <p:nvPicPr>
          <p:cNvPr id="93" name="Google Shape;93;p1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4384900" y="249125"/>
            <a:ext cx="2092425" cy="1966492"/>
          </a:xfrm>
          <a:prstGeom prst="rect">
            <a:avLst/>
          </a:prstGeom>
          <a:noFill/>
          <a:ln>
            <a:noFill/>
          </a:ln>
        </p:spPr>
      </p:pic>
      <p:pic>
        <p:nvPicPr>
          <p:cNvPr id="94" name="Google Shape;94;p1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6818450" y="204125"/>
            <a:ext cx="2427500" cy="1958406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95" name="Google Shape;95;p1"/>
          <p:cNvCxnSpPr/>
          <p:nvPr/>
        </p:nvCxnSpPr>
        <p:spPr>
          <a:xfrm flipH="1">
            <a:off x="8544375" y="914525"/>
            <a:ext cx="227400" cy="226500"/>
          </a:xfrm>
          <a:prstGeom prst="straightConnector1">
            <a:avLst/>
          </a:prstGeom>
          <a:noFill/>
          <a:ln w="19050" cap="flat" cmpd="sng">
            <a:solidFill>
              <a:srgbClr val="000000"/>
            </a:solidFill>
            <a:prstDash val="solid"/>
            <a:round/>
            <a:headEnd type="none" w="sm" len="sm"/>
            <a:tailEnd type="triangle" w="med" len="med"/>
          </a:ln>
        </p:spPr>
      </p:cxnSp>
      <p:cxnSp>
        <p:nvCxnSpPr>
          <p:cNvPr id="96" name="Google Shape;96;p1"/>
          <p:cNvCxnSpPr/>
          <p:nvPr/>
        </p:nvCxnSpPr>
        <p:spPr>
          <a:xfrm flipH="1">
            <a:off x="11056650" y="935025"/>
            <a:ext cx="265500" cy="205800"/>
          </a:xfrm>
          <a:prstGeom prst="straightConnector1">
            <a:avLst/>
          </a:prstGeom>
          <a:noFill/>
          <a:ln w="19050" cap="flat" cmpd="sng">
            <a:solidFill>
              <a:srgbClr val="000000"/>
            </a:solidFill>
            <a:prstDash val="solid"/>
            <a:round/>
            <a:headEnd type="none" w="sm" len="sm"/>
            <a:tailEnd type="triangle" w="med" len="med"/>
          </a:ln>
        </p:spPr>
      </p:cxnSp>
      <p:cxnSp>
        <p:nvCxnSpPr>
          <p:cNvPr id="97" name="Google Shape;97;p1"/>
          <p:cNvCxnSpPr/>
          <p:nvPr/>
        </p:nvCxnSpPr>
        <p:spPr>
          <a:xfrm flipH="1">
            <a:off x="10370850" y="1011225"/>
            <a:ext cx="265500" cy="205800"/>
          </a:xfrm>
          <a:prstGeom prst="straightConnector1">
            <a:avLst/>
          </a:prstGeom>
          <a:noFill/>
          <a:ln w="19050" cap="flat" cmpd="sng">
            <a:solidFill>
              <a:srgbClr val="000000"/>
            </a:solidFill>
            <a:prstDash val="solid"/>
            <a:round/>
            <a:headEnd type="none" w="sm" len="sm"/>
            <a:tailEnd type="triangle" w="med" len="med"/>
          </a:ln>
        </p:spPr>
      </p:cxnSp>
      <p:cxnSp>
        <p:nvCxnSpPr>
          <p:cNvPr id="98" name="Google Shape;98;p1"/>
          <p:cNvCxnSpPr/>
          <p:nvPr/>
        </p:nvCxnSpPr>
        <p:spPr>
          <a:xfrm flipH="1">
            <a:off x="8772975" y="1524125"/>
            <a:ext cx="227400" cy="226500"/>
          </a:xfrm>
          <a:prstGeom prst="straightConnector1">
            <a:avLst/>
          </a:prstGeom>
          <a:noFill/>
          <a:ln w="19050" cap="flat" cmpd="sng">
            <a:solidFill>
              <a:srgbClr val="000000"/>
            </a:solidFill>
            <a:prstDash val="solid"/>
            <a:round/>
            <a:headEnd type="none" w="sm" len="sm"/>
            <a:tailEnd type="triangle" w="med" len="med"/>
          </a:ln>
        </p:spPr>
      </p:cxnSp>
      <p:pic>
        <p:nvPicPr>
          <p:cNvPr id="99" name="Google Shape;99;p1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6523275" y="2846362"/>
            <a:ext cx="1945050" cy="2334056"/>
          </a:xfrm>
          <a:prstGeom prst="rect">
            <a:avLst/>
          </a:prstGeom>
          <a:noFill/>
          <a:ln>
            <a:noFill/>
          </a:ln>
        </p:spPr>
      </p:pic>
      <p:pic>
        <p:nvPicPr>
          <p:cNvPr id="100" name="Google Shape;100;p1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3294825" y="2857325"/>
            <a:ext cx="3017976" cy="22634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1" name="Google Shape;101;p1"/>
          <p:cNvPicPr preferRelativeResize="0"/>
          <p:nvPr/>
        </p:nvPicPr>
        <p:blipFill rotWithShape="1">
          <a:blip r:embed="rId9">
            <a:alphaModFix/>
          </a:blip>
          <a:srcRect b="10410"/>
          <a:stretch/>
        </p:blipFill>
        <p:spPr>
          <a:xfrm>
            <a:off x="8768925" y="2370788"/>
            <a:ext cx="3195311" cy="2862563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" name="Google Shape;102;p1"/>
          <p:cNvPicPr preferRelativeResize="0"/>
          <p:nvPr/>
        </p:nvPicPr>
        <p:blipFill rotWithShape="1">
          <a:blip r:embed="rId10">
            <a:alphaModFix/>
          </a:blip>
          <a:srcRect l="7074" t="9242" r="4719" b="15794"/>
          <a:stretch/>
        </p:blipFill>
        <p:spPr>
          <a:xfrm>
            <a:off x="730100" y="375275"/>
            <a:ext cx="2548301" cy="216562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Google Shape;107;p5"/>
          <p:cNvSpPr txBox="1"/>
          <p:nvPr/>
        </p:nvSpPr>
        <p:spPr>
          <a:xfrm>
            <a:off x="255475" y="4228374"/>
            <a:ext cx="98379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8" name="Google Shape;108;p5"/>
          <p:cNvPicPr preferRelativeResize="0"/>
          <p:nvPr/>
        </p:nvPicPr>
        <p:blipFill rotWithShape="1">
          <a:blip r:embed="rId3">
            <a:alphaModFix/>
          </a:blip>
          <a:srcRect l="14396" t="10717" r="6149" b="10709"/>
          <a:stretch/>
        </p:blipFill>
        <p:spPr>
          <a:xfrm>
            <a:off x="522476" y="436450"/>
            <a:ext cx="1847347" cy="1796808"/>
          </a:xfrm>
          <a:prstGeom prst="rect">
            <a:avLst/>
          </a:prstGeom>
          <a:noFill/>
          <a:ln>
            <a:noFill/>
          </a:ln>
        </p:spPr>
      </p:pic>
      <p:pic>
        <p:nvPicPr>
          <p:cNvPr id="109" name="Google Shape;109;p5"/>
          <p:cNvPicPr preferRelativeResize="0"/>
          <p:nvPr/>
        </p:nvPicPr>
        <p:blipFill rotWithShape="1">
          <a:blip r:embed="rId4">
            <a:alphaModFix/>
          </a:blip>
          <a:srcRect l="11740" t="8085" r="13189" b="13341"/>
          <a:stretch/>
        </p:blipFill>
        <p:spPr>
          <a:xfrm>
            <a:off x="2188900" y="360241"/>
            <a:ext cx="1745290" cy="1796808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5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3989226" y="536300"/>
            <a:ext cx="4035533" cy="3727602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5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056650" y="2332750"/>
            <a:ext cx="2515530" cy="1796799"/>
          </a:xfrm>
          <a:prstGeom prst="rect">
            <a:avLst/>
          </a:prstGeom>
          <a:noFill/>
          <a:ln>
            <a:noFill/>
          </a:ln>
        </p:spPr>
      </p:pic>
      <p:pic>
        <p:nvPicPr>
          <p:cNvPr id="112" name="Google Shape;112;p5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8024752" y="579620"/>
            <a:ext cx="4014750" cy="3640960"/>
          </a:xfrm>
          <a:prstGeom prst="rect">
            <a:avLst/>
          </a:prstGeom>
          <a:noFill/>
          <a:ln>
            <a:noFill/>
          </a:ln>
        </p:spPr>
      </p:pic>
      <p:sp>
        <p:nvSpPr>
          <p:cNvPr id="113" name="Google Shape;113;p5"/>
          <p:cNvSpPr txBox="1"/>
          <p:nvPr/>
        </p:nvSpPr>
        <p:spPr>
          <a:xfrm>
            <a:off x="256891" y="178455"/>
            <a:ext cx="3177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4" name="Google Shape;114;p5"/>
          <p:cNvSpPr txBox="1"/>
          <p:nvPr/>
        </p:nvSpPr>
        <p:spPr>
          <a:xfrm>
            <a:off x="2120391" y="169023"/>
            <a:ext cx="3081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5" name="Google Shape;115;p5"/>
          <p:cNvSpPr txBox="1"/>
          <p:nvPr/>
        </p:nvSpPr>
        <p:spPr>
          <a:xfrm>
            <a:off x="4414366" y="294280"/>
            <a:ext cx="3177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6" name="Google Shape;116;p5"/>
          <p:cNvSpPr txBox="1"/>
          <p:nvPr/>
        </p:nvSpPr>
        <p:spPr>
          <a:xfrm>
            <a:off x="8182866" y="284848"/>
            <a:ext cx="3081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</a:t>
            </a: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7" name="Google Shape;117;p5"/>
          <p:cNvSpPr txBox="1"/>
          <p:nvPr/>
        </p:nvSpPr>
        <p:spPr>
          <a:xfrm>
            <a:off x="321891" y="2203418"/>
            <a:ext cx="3177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</a:t>
            </a: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8105E4C-F9F5-734C-815A-77BC2EFFAB1B}"/>
              </a:ext>
            </a:extLst>
          </p:cNvPr>
          <p:cNvSpPr txBox="1"/>
          <p:nvPr/>
        </p:nvSpPr>
        <p:spPr>
          <a:xfrm>
            <a:off x="82527" y="5403601"/>
            <a:ext cx="12026946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</a:pPr>
            <a:r>
              <a:rPr lang="en-US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2. Soft tissues with pathological calcification up-regulate pathways involved in adaptive immune response, and down-regulate pathways of intracellular transport. (A) Overlap between up-regulated, and (B) down-regulated genes (FDR&lt;0.05) in calcified aorta, artery tibial, and coronary artery. No statistically significant (FDR&lt;0.05) gene changes were found in calcified pituitary. (C) GO and (D) </a:t>
            </a:r>
            <a:r>
              <a:rPr lang="en-US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sigDB</a:t>
            </a:r>
            <a:r>
              <a:rPr lang="en-US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GSEA for differentially expressed genes in calcified aorta, artery tibial, coronary artery and pituitary, as well as all tissues combined together (</a:t>
            </a:r>
            <a:r>
              <a:rPr lang="en-US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ll_Tissues</a:t>
            </a:r>
            <a:r>
              <a:rPr lang="en-US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 adjusted for sex, age, and </a:t>
            </a:r>
            <a:r>
              <a:rPr lang="en-US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ardyScale</a:t>
            </a:r>
            <a:r>
              <a:rPr lang="en-US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f </a:t>
            </a:r>
            <a:r>
              <a:rPr lang="en-US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TEx</a:t>
            </a:r>
            <a:r>
              <a:rPr lang="en-US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ubjects. (E) GSEA for custom-created gene markers of human immune cell populations. Size of the dot is -log10 of FDR-adjusted p-values, and color is normalized enrichment score.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Google Shape;122;p4"/>
          <p:cNvSpPr txBox="1"/>
          <p:nvPr/>
        </p:nvSpPr>
        <p:spPr>
          <a:xfrm>
            <a:off x="213756" y="4970993"/>
            <a:ext cx="116202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3" name="Google Shape;123;p4"/>
          <p:cNvSpPr txBox="1"/>
          <p:nvPr/>
        </p:nvSpPr>
        <p:spPr>
          <a:xfrm>
            <a:off x="28291" y="26055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4" name="Google Shape;124;p4"/>
          <p:cNvSpPr txBox="1"/>
          <p:nvPr/>
        </p:nvSpPr>
        <p:spPr>
          <a:xfrm>
            <a:off x="6235191" y="16623"/>
            <a:ext cx="3081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25" name="Google Shape;125;p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121525" y="395375"/>
            <a:ext cx="5616502" cy="4368699"/>
          </a:xfrm>
          <a:prstGeom prst="rect">
            <a:avLst/>
          </a:prstGeom>
          <a:noFill/>
          <a:ln>
            <a:noFill/>
          </a:ln>
        </p:spPr>
      </p:pic>
      <p:pic>
        <p:nvPicPr>
          <p:cNvPr id="126" name="Google Shape;126;p4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13757" y="395373"/>
            <a:ext cx="5502822" cy="4280272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603C6DE-3015-804A-A7F7-EF6D48468A0E}"/>
              </a:ext>
            </a:extLst>
          </p:cNvPr>
          <p:cNvSpPr txBox="1"/>
          <p:nvPr/>
        </p:nvSpPr>
        <p:spPr>
          <a:xfrm>
            <a:off x="187148" y="5547212"/>
            <a:ext cx="11620199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</a:pPr>
            <a:r>
              <a:rPr lang="en-US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.3 Gene expression correlation between manually assigned calcification grade in human soft tissues for subjects from </a:t>
            </a:r>
            <a:r>
              <a:rPr lang="en-US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TEx</a:t>
            </a:r>
            <a:r>
              <a:rPr lang="en-US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database and (A) expression levels of genes known to be involved in pathological and natural calcification, and (B) expression levels of gene associated with immune-associated inflammation. Pearson correlation coefficients are shown. </a:t>
            </a:r>
            <a:endParaRPr lang="en-US" sz="1100" dirty="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6"/>
          <p:cNvSpPr txBox="1"/>
          <p:nvPr/>
        </p:nvSpPr>
        <p:spPr>
          <a:xfrm>
            <a:off x="0" y="5953447"/>
            <a:ext cx="12015000" cy="10156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algn="just">
              <a:buSzPts val="1400"/>
            </a:pPr>
            <a:r>
              <a:rPr lang="en-US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4. Pathologies co-occurring with pathological calcification. (A ) Number of most common pathologies detected by H&amp;E staining of corresponding human tissues. (B) Calcification grade in aorta, coronary artery and artery tibial that also presents (B) sclerotic changes, (C) </a:t>
            </a:r>
            <a:r>
              <a:rPr lang="en-US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therosis</a:t>
            </a:r>
            <a:r>
              <a:rPr lang="en-US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r (D) atherosclerosis. TRUE - indicate presence of corresponding pathogenic change and, FALSE - indicates the absence of it. P-value was calculated using Mann-Whitney test.</a:t>
            </a:r>
          </a:p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8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32" name="Google Shape;132;p6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5687600" y="3189225"/>
            <a:ext cx="4479551" cy="268773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3" name="Google Shape;133;p6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71525" y="3189213"/>
            <a:ext cx="4680319" cy="2808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34" name="Google Shape;134;p6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5455050" y="416800"/>
            <a:ext cx="4681729" cy="2799673"/>
          </a:xfrm>
          <a:prstGeom prst="rect">
            <a:avLst/>
          </a:prstGeom>
          <a:noFill/>
          <a:ln>
            <a:noFill/>
          </a:ln>
        </p:spPr>
      </p:pic>
      <p:sp>
        <p:nvSpPr>
          <p:cNvPr id="135" name="Google Shape;135;p6"/>
          <p:cNvSpPr txBox="1"/>
          <p:nvPr/>
        </p:nvSpPr>
        <p:spPr>
          <a:xfrm>
            <a:off x="138275" y="0"/>
            <a:ext cx="705300" cy="705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6" name="Google Shape;136;p6"/>
          <p:cNvSpPr txBox="1"/>
          <p:nvPr/>
        </p:nvSpPr>
        <p:spPr>
          <a:xfrm>
            <a:off x="5377992" y="155096"/>
            <a:ext cx="309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7" name="Google Shape;137;p6"/>
          <p:cNvSpPr txBox="1"/>
          <p:nvPr/>
        </p:nvSpPr>
        <p:spPr>
          <a:xfrm>
            <a:off x="239675" y="2919325"/>
            <a:ext cx="502500" cy="56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8" name="Google Shape;138;p6"/>
          <p:cNvSpPr txBox="1"/>
          <p:nvPr/>
        </p:nvSpPr>
        <p:spPr>
          <a:xfrm>
            <a:off x="5373939" y="2919318"/>
            <a:ext cx="3177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</a:t>
            </a: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39" name="Google Shape;139;p6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658125" y="321325"/>
            <a:ext cx="4229616" cy="253777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3</Words>
  <Application>Microsoft Macintosh PowerPoint</Application>
  <PresentationFormat>Широкоэкранный</PresentationFormat>
  <Paragraphs>24</Paragraphs>
  <Slides>4</Slides>
  <Notes>4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2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4</vt:i4>
      </vt:variant>
    </vt:vector>
  </HeadingPairs>
  <TitlesOfParts>
    <vt:vector size="7" baseType="lpstr">
      <vt:lpstr>Arial</vt:lpstr>
      <vt:lpstr>Calibri</vt:lpstr>
      <vt:lpstr>Тема Office</vt:lpstr>
      <vt:lpstr>Презентация PowerPoint</vt:lpstr>
      <vt:lpstr>Презентация PowerPoint</vt:lpstr>
      <vt:lpstr>Презентация PowerPoint</vt:lpstr>
      <vt:lpstr>Презентация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Ибрагимова Аминат Гусейновна</dc:creator>
  <cp:lastModifiedBy>Ибрагимова Аминат Гусейновна</cp:lastModifiedBy>
  <cp:revision>1</cp:revision>
  <dcterms:created xsi:type="dcterms:W3CDTF">2020-11-19T14:51:09Z</dcterms:created>
  <dcterms:modified xsi:type="dcterms:W3CDTF">2022-12-18T11:34:15Z</dcterms:modified>
</cp:coreProperties>
</file>